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7" r:id="rId1"/>
  </p:sldMasterIdLst>
  <p:notesMasterIdLst>
    <p:notesMasterId r:id="rId5"/>
  </p:notesMasterIdLst>
  <p:handoutMasterIdLst>
    <p:handoutMasterId r:id="rId6"/>
  </p:handoutMasterIdLst>
  <p:sldIdLst>
    <p:sldId id="292" r:id="rId2"/>
    <p:sldId id="295" r:id="rId3"/>
    <p:sldId id="294" r:id="rId4"/>
  </p:sldIdLst>
  <p:sldSz cx="6858000" cy="5486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di Haber" initials="AH" lastIdx="1" clrIdx="0">
    <p:extLst>
      <p:ext uri="{19B8F6BF-5375-455C-9EA6-DF929625EA0E}">
        <p15:presenceInfo xmlns:p15="http://schemas.microsoft.com/office/powerpoint/2012/main" userId="S-1-5-21-3249376214-1356155191-3285139299-8164" providerId="AD"/>
      </p:ext>
    </p:extLst>
  </p:cmAuthor>
  <p:cmAuthor id="2" name="Eyal Dor-On" initials="ED" lastIdx="2" clrIdx="1">
    <p:extLst>
      <p:ext uri="{19B8F6BF-5375-455C-9EA6-DF929625EA0E}">
        <p15:presenceInfo xmlns:p15="http://schemas.microsoft.com/office/powerpoint/2012/main" userId="S-1-5-21-3249376214-1356155191-3285139299-22718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854" autoAdjust="0"/>
    <p:restoredTop sz="94660"/>
  </p:normalViewPr>
  <p:slideViewPr>
    <p:cSldViewPr snapToGrid="0">
      <p:cViewPr>
        <p:scale>
          <a:sx n="150" d="100"/>
          <a:sy n="150" d="100"/>
        </p:scale>
        <p:origin x="-660" y="-3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>
      <p:cViewPr varScale="1">
        <p:scale>
          <a:sx n="63" d="100"/>
          <a:sy n="63" d="100"/>
        </p:scale>
        <p:origin x="3126" y="72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11" Type="http://schemas.openxmlformats.org/officeDocument/2006/relationships/tableStyles" Target="tableStyles.xml"/><Relationship Id="rId5" Type="http://schemas.openxmlformats.org/officeDocument/2006/relationships/notesMaster" Target="notesMasters/notesMaster1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image" Target="../media/image5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1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fld id="{92C69C32-0BE9-44C5-A5E8-43BC76C7C3EC}" type="datetimeFigureOut">
              <a:rPr lang="he-IL" smtClean="0"/>
              <a:t>י'/אייר/תשפ"ג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fld id="{62EC592E-24F8-463F-9674-483B552C764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31639088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fld id="{88D500FD-0442-464D-847C-B797BFE7A2B6}" type="datetimeFigureOut">
              <a:rPr lang="he-IL" smtClean="0"/>
              <a:t>י'/אייר/תשפ"ג</a:t>
            </a:fld>
            <a:endParaRPr lang="he-IL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500188" y="1143000"/>
            <a:ext cx="38576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he-IL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fld id="{E569D115-1328-4113-AD7A-A1354EF6D74C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8559382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595549" rtl="0" eaLnBrk="1" latinLnBrk="0" hangingPunct="1">
      <a:defRPr sz="782" kern="1200">
        <a:solidFill>
          <a:schemeClr val="tx1"/>
        </a:solidFill>
        <a:latin typeface="+mn-lt"/>
        <a:ea typeface="+mn-ea"/>
        <a:cs typeface="+mn-cs"/>
      </a:defRPr>
    </a:lvl1pPr>
    <a:lvl2pPr marL="297774" algn="l" defTabSz="595549" rtl="0" eaLnBrk="1" latinLnBrk="0" hangingPunct="1">
      <a:defRPr sz="782" kern="1200">
        <a:solidFill>
          <a:schemeClr val="tx1"/>
        </a:solidFill>
        <a:latin typeface="+mn-lt"/>
        <a:ea typeface="+mn-ea"/>
        <a:cs typeface="+mn-cs"/>
      </a:defRPr>
    </a:lvl2pPr>
    <a:lvl3pPr marL="595549" algn="l" defTabSz="595549" rtl="0" eaLnBrk="1" latinLnBrk="0" hangingPunct="1">
      <a:defRPr sz="782" kern="1200">
        <a:solidFill>
          <a:schemeClr val="tx1"/>
        </a:solidFill>
        <a:latin typeface="+mn-lt"/>
        <a:ea typeface="+mn-ea"/>
        <a:cs typeface="+mn-cs"/>
      </a:defRPr>
    </a:lvl3pPr>
    <a:lvl4pPr marL="893323" algn="l" defTabSz="595549" rtl="0" eaLnBrk="1" latinLnBrk="0" hangingPunct="1">
      <a:defRPr sz="782" kern="1200">
        <a:solidFill>
          <a:schemeClr val="tx1"/>
        </a:solidFill>
        <a:latin typeface="+mn-lt"/>
        <a:ea typeface="+mn-ea"/>
        <a:cs typeface="+mn-cs"/>
      </a:defRPr>
    </a:lvl4pPr>
    <a:lvl5pPr marL="1191097" algn="l" defTabSz="595549" rtl="0" eaLnBrk="1" latinLnBrk="0" hangingPunct="1">
      <a:defRPr sz="782" kern="1200">
        <a:solidFill>
          <a:schemeClr val="tx1"/>
        </a:solidFill>
        <a:latin typeface="+mn-lt"/>
        <a:ea typeface="+mn-ea"/>
        <a:cs typeface="+mn-cs"/>
      </a:defRPr>
    </a:lvl5pPr>
    <a:lvl6pPr marL="1488872" algn="l" defTabSz="595549" rtl="0" eaLnBrk="1" latinLnBrk="0" hangingPunct="1">
      <a:defRPr sz="782" kern="1200">
        <a:solidFill>
          <a:schemeClr val="tx1"/>
        </a:solidFill>
        <a:latin typeface="+mn-lt"/>
        <a:ea typeface="+mn-ea"/>
        <a:cs typeface="+mn-cs"/>
      </a:defRPr>
    </a:lvl6pPr>
    <a:lvl7pPr marL="1786646" algn="l" defTabSz="595549" rtl="0" eaLnBrk="1" latinLnBrk="0" hangingPunct="1">
      <a:defRPr sz="782" kern="1200">
        <a:solidFill>
          <a:schemeClr val="tx1"/>
        </a:solidFill>
        <a:latin typeface="+mn-lt"/>
        <a:ea typeface="+mn-ea"/>
        <a:cs typeface="+mn-cs"/>
      </a:defRPr>
    </a:lvl7pPr>
    <a:lvl8pPr marL="2084421" algn="l" defTabSz="595549" rtl="0" eaLnBrk="1" latinLnBrk="0" hangingPunct="1">
      <a:defRPr sz="782" kern="1200">
        <a:solidFill>
          <a:schemeClr val="tx1"/>
        </a:solidFill>
        <a:latin typeface="+mn-lt"/>
        <a:ea typeface="+mn-ea"/>
        <a:cs typeface="+mn-cs"/>
      </a:defRPr>
    </a:lvl8pPr>
    <a:lvl9pPr marL="2382195" algn="l" defTabSz="595549" rtl="0" eaLnBrk="1" latinLnBrk="0" hangingPunct="1">
      <a:defRPr sz="782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897890"/>
            <a:ext cx="5829300" cy="191008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2881630"/>
            <a:ext cx="5143500" cy="1324610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DC9034-3F46-4778-AD33-22234C126E28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678559-AF4F-4746-B752-13E75320ED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59533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DC9034-3F46-4778-AD33-22234C126E28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678559-AF4F-4746-B752-13E75320ED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98743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292100"/>
            <a:ext cx="1478756" cy="464947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292100"/>
            <a:ext cx="4350544" cy="4649470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DC9034-3F46-4778-AD33-22234C126E28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678559-AF4F-4746-B752-13E75320ED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76281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DC9034-3F46-4778-AD33-22234C126E28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678559-AF4F-4746-B752-13E75320ED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91548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1367791"/>
            <a:ext cx="5915025" cy="228219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3671571"/>
            <a:ext cx="5915025" cy="1200150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DC9034-3F46-4778-AD33-22234C126E28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678559-AF4F-4746-B752-13E75320ED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09844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1460500"/>
            <a:ext cx="2914650" cy="348107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1460500"/>
            <a:ext cx="2914650" cy="348107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DC9034-3F46-4778-AD33-22234C126E28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678559-AF4F-4746-B752-13E75320ED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85882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292101"/>
            <a:ext cx="5915025" cy="106045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1344930"/>
            <a:ext cx="2901255" cy="659130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2004060"/>
            <a:ext cx="2901255" cy="294767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1344930"/>
            <a:ext cx="2915543" cy="659130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2004060"/>
            <a:ext cx="2915543" cy="294767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DC9034-3F46-4778-AD33-22234C126E28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678559-AF4F-4746-B752-13E75320ED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38937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DC9034-3F46-4778-AD33-22234C126E28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678559-AF4F-4746-B752-13E75320ED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29224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DC9034-3F46-4778-AD33-22234C126E28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678559-AF4F-4746-B752-13E75320ED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01302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365760"/>
            <a:ext cx="2211884" cy="128016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789941"/>
            <a:ext cx="3471863" cy="389890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1645920"/>
            <a:ext cx="2211884" cy="304927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DC9034-3F46-4778-AD33-22234C126E28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678559-AF4F-4746-B752-13E75320ED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76311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365760"/>
            <a:ext cx="2211884" cy="128016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789941"/>
            <a:ext cx="3471863" cy="3898900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1645920"/>
            <a:ext cx="2211884" cy="304927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DC9034-3F46-4778-AD33-22234C126E28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678559-AF4F-4746-B752-13E75320ED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42396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292101"/>
            <a:ext cx="5915025" cy="10604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1460500"/>
            <a:ext cx="5915025" cy="348107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5085081"/>
            <a:ext cx="1543050" cy="2921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DC9034-3F46-4778-AD33-22234C126E28}" type="datetimeFigureOut">
              <a:rPr lang="en-US" smtClean="0"/>
              <a:t>5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5085081"/>
            <a:ext cx="2314575" cy="2921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5085081"/>
            <a:ext cx="1543050" cy="2921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678559-AF4F-4746-B752-13E75320ED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72891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8" r:id="rId1"/>
    <p:sldLayoutId id="2147483689" r:id="rId2"/>
    <p:sldLayoutId id="2147483690" r:id="rId3"/>
    <p:sldLayoutId id="2147483691" r:id="rId4"/>
    <p:sldLayoutId id="2147483692" r:id="rId5"/>
    <p:sldLayoutId id="2147483693" r:id="rId6"/>
    <p:sldLayoutId id="2147483694" r:id="rId7"/>
    <p:sldLayoutId id="2147483695" r:id="rId8"/>
    <p:sldLayoutId id="2147483696" r:id="rId9"/>
    <p:sldLayoutId id="2147483697" r:id="rId10"/>
    <p:sldLayoutId id="2147483698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.bin"/><Relationship Id="rId3" Type="http://schemas.openxmlformats.org/officeDocument/2006/relationships/oleObject" Target="../embeddings/oleObject1.bin"/><Relationship Id="rId7" Type="http://schemas.microsoft.com/office/2007/relationships/hdphoto" Target="../media/hdphoto1.wdp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1.emf"/><Relationship Id="rId9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emf"/><Relationship Id="rId13" Type="http://schemas.microsoft.com/office/2007/relationships/hdphoto" Target="../media/hdphoto4.wdp"/><Relationship Id="rId3" Type="http://schemas.openxmlformats.org/officeDocument/2006/relationships/image" Target="../media/image7.png"/><Relationship Id="rId7" Type="http://schemas.openxmlformats.org/officeDocument/2006/relationships/oleObject" Target="../embeddings/oleObject3.bin"/><Relationship Id="rId12" Type="http://schemas.openxmlformats.org/officeDocument/2006/relationships/image" Target="../media/image10.png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2.vml"/><Relationship Id="rId6" Type="http://schemas.microsoft.com/office/2007/relationships/hdphoto" Target="../media/hdphoto3.wdp"/><Relationship Id="rId11" Type="http://schemas.openxmlformats.org/officeDocument/2006/relationships/image" Target="../media/image9.tif"/><Relationship Id="rId5" Type="http://schemas.openxmlformats.org/officeDocument/2006/relationships/image" Target="../media/image8.png"/><Relationship Id="rId10" Type="http://schemas.openxmlformats.org/officeDocument/2006/relationships/image" Target="../media/image6.emf"/><Relationship Id="rId4" Type="http://schemas.microsoft.com/office/2007/relationships/hdphoto" Target="../media/hdphoto2.wdp"/><Relationship Id="rId9" Type="http://schemas.openxmlformats.org/officeDocument/2006/relationships/oleObject" Target="../embeddings/oleObject4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1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673B5A12-E2B7-4CEE-89E5-98218B3D435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34560788"/>
              </p:ext>
            </p:extLst>
          </p:nvPr>
        </p:nvGraphicFramePr>
        <p:xfrm>
          <a:off x="690268" y="573731"/>
          <a:ext cx="2287787" cy="13885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218" name="Prism 9" r:id="rId3" imgW="4067733" imgH="2469203" progId="Prism9.Document">
                  <p:embed/>
                </p:oleObj>
              </mc:Choice>
              <mc:Fallback>
                <p:oleObj name="Prism 9" r:id="rId3" imgW="4067733" imgH="2469203" progId="Prism9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673B5A12-E2B7-4CEE-89E5-98218B3D435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90268" y="573731"/>
                        <a:ext cx="2287787" cy="13885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5" name="Picture 4">
            <a:extLst>
              <a:ext uri="{FF2B5EF4-FFF2-40B4-BE49-F238E27FC236}">
                <a16:creationId xmlns:a16="http://schemas.microsoft.com/office/drawing/2014/main" id="{F3031D63-106E-4444-98BE-76A7CCB3A1E2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3763" t="19322" r="47240" b="32634"/>
          <a:stretch/>
        </p:blipFill>
        <p:spPr>
          <a:xfrm flipH="1">
            <a:off x="1201435" y="1945525"/>
            <a:ext cx="1481999" cy="18604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D9E90107-6ACA-43E5-8100-F54F54243E93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rcRect l="20105" t="24390" r="7715" b="20423"/>
          <a:stretch/>
        </p:blipFill>
        <p:spPr>
          <a:xfrm>
            <a:off x="1201432" y="2183514"/>
            <a:ext cx="1481328" cy="17319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" name="TextBox 13">
            <a:extLst>
              <a:ext uri="{FF2B5EF4-FFF2-40B4-BE49-F238E27FC236}">
                <a16:creationId xmlns:a16="http://schemas.microsoft.com/office/drawing/2014/main" id="{71DCF968-6705-49CA-A7E9-43796FAE67C5}"/>
              </a:ext>
            </a:extLst>
          </p:cNvPr>
          <p:cNvSpPr txBox="1"/>
          <p:nvPr/>
        </p:nvSpPr>
        <p:spPr>
          <a:xfrm>
            <a:off x="811082" y="1942478"/>
            <a:ext cx="471604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788" dirty="0"/>
              <a:t>MGMT</a:t>
            </a:r>
          </a:p>
        </p:txBody>
      </p:sp>
      <p:sp>
        <p:nvSpPr>
          <p:cNvPr id="12" name="TextBox 14">
            <a:extLst>
              <a:ext uri="{FF2B5EF4-FFF2-40B4-BE49-F238E27FC236}">
                <a16:creationId xmlns:a16="http://schemas.microsoft.com/office/drawing/2014/main" id="{EE60973E-42D2-444D-8FFC-FE9F8F6D5DBF}"/>
              </a:ext>
            </a:extLst>
          </p:cNvPr>
          <p:cNvSpPr txBox="1"/>
          <p:nvPr/>
        </p:nvSpPr>
        <p:spPr>
          <a:xfrm>
            <a:off x="784931" y="2186570"/>
            <a:ext cx="484428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788" dirty="0"/>
              <a:t>GAPDH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0CDF7A2-E15A-4F71-85C7-2A1CC0046F59}"/>
              </a:ext>
            </a:extLst>
          </p:cNvPr>
          <p:cNvSpPr txBox="1"/>
          <p:nvPr/>
        </p:nvSpPr>
        <p:spPr>
          <a:xfrm>
            <a:off x="118101" y="148413"/>
            <a:ext cx="602538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 S1</a:t>
            </a:r>
            <a:endParaRPr lang="en-US" sz="1350" dirty="0"/>
          </a:p>
        </p:txBody>
      </p:sp>
      <p:graphicFrame>
        <p:nvGraphicFramePr>
          <p:cNvPr id="30" name="Object 29">
            <a:extLst>
              <a:ext uri="{FF2B5EF4-FFF2-40B4-BE49-F238E27FC236}">
                <a16:creationId xmlns:a16="http://schemas.microsoft.com/office/drawing/2014/main" id="{C5CED290-E515-4393-8363-3924F807268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1791614"/>
              </p:ext>
            </p:extLst>
          </p:nvPr>
        </p:nvGraphicFramePr>
        <p:xfrm>
          <a:off x="3468688" y="549275"/>
          <a:ext cx="2603500" cy="1847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219" name="Prism 9" r:id="rId8" imgW="4349719" imgH="3089564" progId="Prism9.Document">
                  <p:embed/>
                </p:oleObj>
              </mc:Choice>
              <mc:Fallback>
                <p:oleObj name="Prism 9" r:id="rId8" imgW="4349719" imgH="3089564" progId="Prism9.Document">
                  <p:embed/>
                  <p:pic>
                    <p:nvPicPr>
                      <p:cNvPr id="30" name="Object 29">
                        <a:extLst>
                          <a:ext uri="{FF2B5EF4-FFF2-40B4-BE49-F238E27FC236}">
                            <a16:creationId xmlns:a16="http://schemas.microsoft.com/office/drawing/2014/main" id="{C5CED290-E515-4393-8363-3924F807268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468688" y="549275"/>
                        <a:ext cx="2603500" cy="18478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1" name="TextBox 30">
            <a:extLst>
              <a:ext uri="{FF2B5EF4-FFF2-40B4-BE49-F238E27FC236}">
                <a16:creationId xmlns:a16="http://schemas.microsoft.com/office/drawing/2014/main" id="{290C1874-0ED0-42B3-9AB8-AB667D75FA42}"/>
              </a:ext>
            </a:extLst>
          </p:cNvPr>
          <p:cNvSpPr txBox="1"/>
          <p:nvPr/>
        </p:nvSpPr>
        <p:spPr>
          <a:xfrm>
            <a:off x="3220561" y="573730"/>
            <a:ext cx="184716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B</a:t>
            </a:r>
            <a:endParaRPr lang="en-US" sz="1350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AD325C0-71C5-473F-A87F-D4A72D521787}"/>
              </a:ext>
            </a:extLst>
          </p:cNvPr>
          <p:cNvSpPr txBox="1"/>
          <p:nvPr/>
        </p:nvSpPr>
        <p:spPr>
          <a:xfrm>
            <a:off x="453955" y="573730"/>
            <a:ext cx="184716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A</a:t>
            </a:r>
            <a:endParaRPr lang="en-US" sz="1350" dirty="0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9369BACB-D5C8-4301-A67C-38E9345B443F}"/>
              </a:ext>
            </a:extLst>
          </p:cNvPr>
          <p:cNvSpPr/>
          <p:nvPr/>
        </p:nvSpPr>
        <p:spPr>
          <a:xfrm>
            <a:off x="301505" y="2873357"/>
            <a:ext cx="6254989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sz="11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1. MGMT expression level and TMZ sensitivity in the various GBM cell lines.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GMT protein expression levels (A) and cell count following 72 h treatment with various TMZ doses (B) in U-87 MG, LN-229</a:t>
            </a:r>
            <a:r>
              <a:rPr lang="en-US" sz="110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U-118 MG, 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 LN-18 human GBM cells. Values are mean ± SEM.</a:t>
            </a:r>
          </a:p>
        </p:txBody>
      </p:sp>
    </p:spTree>
    <p:extLst>
      <p:ext uri="{BB962C8B-B14F-4D97-AF65-F5344CB8AC3E}">
        <p14:creationId xmlns:p14="http://schemas.microsoft.com/office/powerpoint/2010/main" val="12906271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CA39B735-51D6-44F0-B530-B050DF840A02}"/>
              </a:ext>
            </a:extLst>
          </p:cNvPr>
          <p:cNvGrpSpPr/>
          <p:nvPr/>
        </p:nvGrpSpPr>
        <p:grpSpPr>
          <a:xfrm>
            <a:off x="1265131" y="2114094"/>
            <a:ext cx="1239103" cy="637240"/>
            <a:chOff x="1265131" y="2114094"/>
            <a:chExt cx="1239103" cy="637240"/>
          </a:xfrm>
        </p:grpSpPr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26E6AD8A-5762-4267-91A6-C9E83D47FF3F}"/>
                </a:ext>
              </a:extLst>
            </p:cNvPr>
            <p:cNvSpPr txBox="1"/>
            <p:nvPr/>
          </p:nvSpPr>
          <p:spPr>
            <a:xfrm>
              <a:off x="1604445" y="2150237"/>
              <a:ext cx="500173" cy="1962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75" dirty="0"/>
                <a:t>U-87 MG</a:t>
              </a:r>
              <a:endParaRPr lang="LID4096" sz="675" dirty="0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F654E311-D19C-4675-AC51-C66438FAB998}"/>
                </a:ext>
              </a:extLst>
            </p:cNvPr>
            <p:cNvSpPr txBox="1"/>
            <p:nvPr/>
          </p:nvSpPr>
          <p:spPr>
            <a:xfrm>
              <a:off x="1948809" y="2114094"/>
              <a:ext cx="555425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75" dirty="0"/>
                <a:t>TMZ-R </a:t>
              </a:r>
            </a:p>
            <a:p>
              <a:pPr algn="ctr"/>
              <a:r>
                <a:rPr lang="en-US" sz="675" dirty="0"/>
                <a:t>U-87 MG</a:t>
              </a:r>
              <a:endParaRPr lang="LID4096" sz="675" dirty="0"/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1E2DD75E-2AF0-426E-B319-72006BFC357A}"/>
                </a:ext>
              </a:extLst>
            </p:cNvPr>
            <p:cNvSpPr txBox="1"/>
            <p:nvPr/>
          </p:nvSpPr>
          <p:spPr>
            <a:xfrm>
              <a:off x="1265131" y="2555126"/>
              <a:ext cx="469810" cy="1962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75" dirty="0"/>
                <a:t>GAPDH</a:t>
              </a:r>
              <a:endParaRPr lang="LID4096" sz="675" dirty="0"/>
            </a:p>
          </p:txBody>
        </p:sp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28B98F79-AA4F-4F63-BE05-1BE1EA2D1A9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email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l="6197" t="7282" r="2807" b="-798"/>
            <a:stretch/>
          </p:blipFill>
          <p:spPr>
            <a:xfrm>
              <a:off x="1690041" y="2561493"/>
              <a:ext cx="689173" cy="14570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CB675CE2-43E0-4DF3-AD8C-61CFE32C43A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email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l="9005" t="19857" b="-1"/>
            <a:stretch/>
          </p:blipFill>
          <p:spPr>
            <a:xfrm>
              <a:off x="1690041" y="2377454"/>
              <a:ext cx="689173" cy="15031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5E27E411-71E6-4F5C-82F7-51BBEC319C1F}"/>
                </a:ext>
              </a:extLst>
            </p:cNvPr>
            <p:cNvSpPr txBox="1"/>
            <p:nvPr/>
          </p:nvSpPr>
          <p:spPr>
            <a:xfrm>
              <a:off x="1276924" y="2369709"/>
              <a:ext cx="469810" cy="1962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75" dirty="0"/>
                <a:t>MGMT</a:t>
              </a:r>
              <a:endParaRPr lang="LID4096" sz="675" dirty="0"/>
            </a:p>
          </p:txBody>
        </p:sp>
      </p:grpSp>
      <p:graphicFrame>
        <p:nvGraphicFramePr>
          <p:cNvPr id="29" name="Object 28">
            <a:extLst>
              <a:ext uri="{FF2B5EF4-FFF2-40B4-BE49-F238E27FC236}">
                <a16:creationId xmlns:a16="http://schemas.microsoft.com/office/drawing/2014/main" id="{AB256378-6031-4FE5-B21B-DD123321DFD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24108596"/>
              </p:ext>
            </p:extLst>
          </p:nvPr>
        </p:nvGraphicFramePr>
        <p:xfrm>
          <a:off x="1222865" y="697606"/>
          <a:ext cx="2223492" cy="1393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8178" name="Prism 9" r:id="rId7" imgW="4285615" imgH="2687032" progId="Prism9.Document">
                  <p:embed/>
                </p:oleObj>
              </mc:Choice>
              <mc:Fallback>
                <p:oleObj name="Prism 9" r:id="rId7" imgW="4285615" imgH="2687032" progId="Prism9.Document">
                  <p:embed/>
                  <p:pic>
                    <p:nvPicPr>
                      <p:cNvPr id="29" name="Object 28">
                        <a:extLst>
                          <a:ext uri="{FF2B5EF4-FFF2-40B4-BE49-F238E27FC236}">
                            <a16:creationId xmlns:a16="http://schemas.microsoft.com/office/drawing/2014/main" id="{AB256378-6031-4FE5-B21B-DD123321DFD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222865" y="697606"/>
                        <a:ext cx="2223492" cy="1393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3" name="Object 32">
            <a:extLst>
              <a:ext uri="{FF2B5EF4-FFF2-40B4-BE49-F238E27FC236}">
                <a16:creationId xmlns:a16="http://schemas.microsoft.com/office/drawing/2014/main" id="{14AE2159-1962-4C34-BDF3-6ED065D9965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54912322"/>
              </p:ext>
            </p:extLst>
          </p:nvPr>
        </p:nvGraphicFramePr>
        <p:xfrm>
          <a:off x="3949700" y="693738"/>
          <a:ext cx="2260600" cy="13954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8179" name="Prism 9" r:id="rId9" imgW="4355841" imgH="2687032" progId="Prism9.Document">
                  <p:embed/>
                </p:oleObj>
              </mc:Choice>
              <mc:Fallback>
                <p:oleObj name="Prism 9" r:id="rId9" imgW="4355841" imgH="2687032" progId="Prism9.Document">
                  <p:embed/>
                  <p:pic>
                    <p:nvPicPr>
                      <p:cNvPr id="33" name="Object 32">
                        <a:extLst>
                          <a:ext uri="{FF2B5EF4-FFF2-40B4-BE49-F238E27FC236}">
                            <a16:creationId xmlns:a16="http://schemas.microsoft.com/office/drawing/2014/main" id="{14AE2159-1962-4C34-BDF3-6ED065D9965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949700" y="693738"/>
                        <a:ext cx="2260600" cy="13954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4" name="TextBox 33">
            <a:extLst>
              <a:ext uri="{FF2B5EF4-FFF2-40B4-BE49-F238E27FC236}">
                <a16:creationId xmlns:a16="http://schemas.microsoft.com/office/drawing/2014/main" id="{057F97F0-65DE-42A8-8D50-13A7E25CD29F}"/>
              </a:ext>
            </a:extLst>
          </p:cNvPr>
          <p:cNvSpPr txBox="1"/>
          <p:nvPr/>
        </p:nvSpPr>
        <p:spPr>
          <a:xfrm>
            <a:off x="3767816" y="658744"/>
            <a:ext cx="184716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B</a:t>
            </a:r>
            <a:endParaRPr lang="en-US" sz="1350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8D540B0E-661D-4435-BBCB-1C8A85FC91ED}"/>
              </a:ext>
            </a:extLst>
          </p:cNvPr>
          <p:cNvSpPr txBox="1"/>
          <p:nvPr/>
        </p:nvSpPr>
        <p:spPr>
          <a:xfrm>
            <a:off x="1001210" y="658744"/>
            <a:ext cx="184716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A</a:t>
            </a:r>
            <a:endParaRPr lang="en-US" sz="1350" dirty="0"/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C0C2499C-D2EB-47BA-840D-0A36488D2B4D}"/>
              </a:ext>
            </a:extLst>
          </p:cNvPr>
          <p:cNvSpPr/>
          <p:nvPr/>
        </p:nvSpPr>
        <p:spPr>
          <a:xfrm>
            <a:off x="301505" y="2873357"/>
            <a:ext cx="6254989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sz="11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2. MGMT expression level and TMZ sensitivity in TMZ-resistant cells.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ell count following 72 h treatment with various TMZ doses and MGMT protein expression levels in U-87 MG (A) and U-118 MG (B) parental cells and TMZ resistant cells (TMZ-R cells), generated by repeatedly exposure to high dose TMZ. Values are mean ± SEM. 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44B5FB70-32FA-4094-8FE3-49AE3AFEE77B}"/>
              </a:ext>
            </a:extLst>
          </p:cNvPr>
          <p:cNvGrpSpPr/>
          <p:nvPr/>
        </p:nvGrpSpPr>
        <p:grpSpPr>
          <a:xfrm>
            <a:off x="4128220" y="2118327"/>
            <a:ext cx="1212258" cy="622375"/>
            <a:chOff x="4128220" y="2118327"/>
            <a:chExt cx="1212258" cy="622375"/>
          </a:xfrm>
        </p:grpSpPr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45E510AF-E14B-4542-85AB-870964131230}"/>
                </a:ext>
              </a:extLst>
            </p:cNvPr>
            <p:cNvSpPr txBox="1"/>
            <p:nvPr/>
          </p:nvSpPr>
          <p:spPr>
            <a:xfrm>
              <a:off x="4128220" y="2544494"/>
              <a:ext cx="469809" cy="1962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75" dirty="0"/>
                <a:t>GAPDH</a:t>
              </a:r>
              <a:endParaRPr lang="LID4096" sz="675" dirty="0"/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04A837EE-6888-460C-BEBC-E24E510C9F2C}"/>
                </a:ext>
              </a:extLst>
            </p:cNvPr>
            <p:cNvSpPr txBox="1"/>
            <p:nvPr/>
          </p:nvSpPr>
          <p:spPr>
            <a:xfrm>
              <a:off x="4140014" y="2359077"/>
              <a:ext cx="469809" cy="1962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75" dirty="0"/>
                <a:t>MGMT</a:t>
              </a:r>
              <a:endParaRPr lang="LID4096" sz="675" dirty="0"/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CCE29865-2955-4A17-96F4-99C46BEFF017}"/>
                </a:ext>
              </a:extLst>
            </p:cNvPr>
            <p:cNvSpPr txBox="1"/>
            <p:nvPr/>
          </p:nvSpPr>
          <p:spPr>
            <a:xfrm>
              <a:off x="4425713" y="2141771"/>
              <a:ext cx="555425" cy="1962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75" dirty="0"/>
                <a:t>U-118 MG</a:t>
              </a:r>
              <a:endParaRPr lang="LID4096" sz="675" dirty="0"/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B506402D-933E-4011-A038-D4E7F57EFC48}"/>
                </a:ext>
              </a:extLst>
            </p:cNvPr>
            <p:cNvSpPr txBox="1"/>
            <p:nvPr/>
          </p:nvSpPr>
          <p:spPr>
            <a:xfrm>
              <a:off x="4785053" y="2118327"/>
              <a:ext cx="555425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75" dirty="0"/>
                <a:t>TMZ-R </a:t>
              </a:r>
            </a:p>
            <a:p>
              <a:pPr algn="ctr"/>
              <a:r>
                <a:rPr lang="en-US" sz="675" dirty="0"/>
                <a:t>U-118 MG</a:t>
              </a:r>
              <a:endParaRPr lang="LID4096" sz="675" dirty="0"/>
            </a:p>
          </p:txBody>
        </p:sp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5059769C-312D-4EA3-91D2-ACB6D1E4861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499" t="41414" r="42866" b="53535"/>
            <a:stretch/>
          </p:blipFill>
          <p:spPr>
            <a:xfrm>
              <a:off x="4533997" y="2560456"/>
              <a:ext cx="682083" cy="14674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9409084D-E0FF-4162-ADFD-6B630B7E5B8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492" t="21236" r="45472" b="73237"/>
            <a:stretch/>
          </p:blipFill>
          <p:spPr>
            <a:xfrm>
              <a:off x="4533996" y="2377454"/>
              <a:ext cx="682083" cy="14674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id="{9281FDAE-09CD-4782-AEB9-CA8E1DE811B8}"/>
              </a:ext>
            </a:extLst>
          </p:cNvPr>
          <p:cNvSpPr txBox="1"/>
          <p:nvPr/>
        </p:nvSpPr>
        <p:spPr>
          <a:xfrm>
            <a:off x="118101" y="148413"/>
            <a:ext cx="602538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 S2</a:t>
            </a:r>
            <a:endParaRPr lang="en-US" sz="1350" dirty="0"/>
          </a:p>
        </p:txBody>
      </p:sp>
    </p:spTree>
    <p:extLst>
      <p:ext uri="{BB962C8B-B14F-4D97-AF65-F5344CB8AC3E}">
        <p14:creationId xmlns:p14="http://schemas.microsoft.com/office/powerpoint/2010/main" val="29497971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BDB674D7-9BDF-43E9-9519-FCA9C65B5B4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88440194"/>
              </p:ext>
            </p:extLst>
          </p:nvPr>
        </p:nvGraphicFramePr>
        <p:xfrm>
          <a:off x="930275" y="595313"/>
          <a:ext cx="2592388" cy="1847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4095" name="Prism 9" r:id="rId3" imgW="4334233" imgH="3089564" progId="Prism9.Document">
                  <p:embed/>
                </p:oleObj>
              </mc:Choice>
              <mc:Fallback>
                <p:oleObj name="Prism 9" r:id="rId3" imgW="4334233" imgH="3089564" progId="Prism9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BDB674D7-9BDF-43E9-9519-FCA9C65B5B4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930275" y="595313"/>
                        <a:ext cx="2592388" cy="18478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Rectangle 9">
            <a:extLst>
              <a:ext uri="{FF2B5EF4-FFF2-40B4-BE49-F238E27FC236}">
                <a16:creationId xmlns:a16="http://schemas.microsoft.com/office/drawing/2014/main" id="{33E3BCB4-8830-485A-83AD-A764656D102A}"/>
              </a:ext>
            </a:extLst>
          </p:cNvPr>
          <p:cNvSpPr/>
          <p:nvPr/>
        </p:nvSpPr>
        <p:spPr>
          <a:xfrm>
            <a:off x="301505" y="2873357"/>
            <a:ext cx="6254989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sz="11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3. CCNU sensitivity in the various GBM cell lines.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ell count following 72 h treatment with various CCNU doses in </a:t>
            </a:r>
            <a:r>
              <a:rPr lang="en-US" sz="1100" dirty="0">
                <a:latin typeface="Calibri" panose="020F0502020204030204" pitchFamily="34" charset="0"/>
                <a:cs typeface="Arial" panose="020B0604020202020204" pitchFamily="34" charset="0"/>
              </a:rPr>
              <a:t>MGMT promotor methylated U-87 MG and LN-229 cells and in MGMT promotor unmethylated U-118 MG and LN-18 cells. 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alues are mean ± SEM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AFA6B2C-F091-47E9-8EBC-6770E09A07DB}"/>
              </a:ext>
            </a:extLst>
          </p:cNvPr>
          <p:cNvSpPr txBox="1"/>
          <p:nvPr/>
        </p:nvSpPr>
        <p:spPr>
          <a:xfrm>
            <a:off x="118101" y="148413"/>
            <a:ext cx="602538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 S3</a:t>
            </a:r>
            <a:endParaRPr lang="en-US" sz="1350" dirty="0"/>
          </a:p>
        </p:txBody>
      </p:sp>
    </p:spTree>
    <p:extLst>
      <p:ext uri="{BB962C8B-B14F-4D97-AF65-F5344CB8AC3E}">
        <p14:creationId xmlns:p14="http://schemas.microsoft.com/office/powerpoint/2010/main" val="32618469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5015</TotalTime>
  <Words>197</Words>
  <Application>Microsoft Office PowerPoint</Application>
  <PresentationFormat>Custom</PresentationFormat>
  <Paragraphs>22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rism 9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i Haber</dc:creator>
  <cp:lastModifiedBy>Adi Haber</cp:lastModifiedBy>
  <cp:revision>347</cp:revision>
  <dcterms:created xsi:type="dcterms:W3CDTF">2022-06-06T12:40:09Z</dcterms:created>
  <dcterms:modified xsi:type="dcterms:W3CDTF">2023-05-01T07:44:43Z</dcterms:modified>
</cp:coreProperties>
</file>